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5321"/>
  </p:normalViewPr>
  <p:slideViewPr>
    <p:cSldViewPr snapToGrid="0" snapToObjects="1">
      <p:cViewPr varScale="1">
        <p:scale>
          <a:sx n="99" d="100"/>
          <a:sy n="99" d="100"/>
        </p:scale>
        <p:origin x="52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FBA4885-8FD7-6644-AA00-842D96F17DB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103B19CD-B212-1F44-9415-BEA172D5D89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68CA9043-CF00-F341-952E-1B6D676884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01DE97-4C2A-5541-BFCD-3963385E15CF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747E4A17-A91B-0547-B23E-C9E4B384F4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6CB6A2AB-DC03-754C-A866-4BBCFC7471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EFF073-A968-994A-B6F4-4DB2CA7BF4AA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3665382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4BA50B7-0CE1-B94B-A8E6-C29A162E29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4E87C549-CE30-4C48-96FC-79DECD0B675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FE6E81D8-2E1B-BF40-995F-4EBFABE9B1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01DE97-4C2A-5541-BFCD-3963385E15CF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6ED3E12C-A89F-1D44-B01A-F83C1F2767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72DD641E-9144-6C44-B4A6-41B3AFED02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EFF073-A968-994A-B6F4-4DB2CA7BF4AA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9550676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4BD84737-DFE3-D843-AA7F-D837395B962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D8FB55E7-411E-9A41-AE64-7998267B728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6B2F2615-E854-9346-9C84-FC6B013FB3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01DE97-4C2A-5541-BFCD-3963385E15CF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1ED65B90-A06E-384B-9886-E2A9855CB9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3B975797-5C67-B74C-8814-0110CBEF57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EFF073-A968-994A-B6F4-4DB2CA7BF4AA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7732747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FC343A9-3233-384D-A0B4-667524D06B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4FEDA85F-57F6-AA41-9FB7-48574932535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5EFBCF02-1943-2A4A-B145-7E6E93B3AA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01DE97-4C2A-5541-BFCD-3963385E15CF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B0FB7113-3B39-FD4C-9911-284ED0E81F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07DFA338-3A2C-4D43-B90D-81D5144A77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EFF073-A968-994A-B6F4-4DB2CA7BF4AA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5325554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1020A28-4B0A-6749-92D1-51B08D4055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5CA01987-FE04-BD4D-8C2A-C7729A7CE7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5F77B4B0-0596-9647-8AC2-6678354369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01DE97-4C2A-5541-BFCD-3963385E15CF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E71263B5-345D-E241-ABC5-6208A3B147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E9EC99CC-8766-BD4F-A54C-0C9727E552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EFF073-A968-994A-B6F4-4DB2CA7BF4AA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4886472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4F2D539-56D8-3646-8B44-4CCFCBF679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3594AEEB-E989-6F44-9D64-09C15C9FE12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A7A75F14-D060-F243-A1E9-3E530EA8A5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40DF3956-7450-A04E-B654-5CBE43DF41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01DE97-4C2A-5541-BFCD-3963385E15CF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1802205B-216F-2C41-9C4C-B7D0679B95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06057006-A770-EB40-935B-CD84D56F9C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EFF073-A968-994A-B6F4-4DB2CA7BF4AA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1407093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C166054-DAA3-9D4C-AB3A-C2E54F67DC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57477C53-BCBC-EF4C-9EF3-9D7DEB2B60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918D74B5-5D11-4B4A-8C12-6EA2BC8D26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>
            <a:extLst>
              <a:ext uri="{FF2B5EF4-FFF2-40B4-BE49-F238E27FC236}">
                <a16:creationId xmlns:a16="http://schemas.microsoft.com/office/drawing/2014/main" id="{CFC04AF2-5F30-BD47-BB7E-1BC2AC20326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Espaço Reservado para Conteúdo 5">
            <a:extLst>
              <a:ext uri="{FF2B5EF4-FFF2-40B4-BE49-F238E27FC236}">
                <a16:creationId xmlns:a16="http://schemas.microsoft.com/office/drawing/2014/main" id="{C6A2984B-FB9F-6B4D-9183-49BB3B2C4F7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>
            <a:extLst>
              <a:ext uri="{FF2B5EF4-FFF2-40B4-BE49-F238E27FC236}">
                <a16:creationId xmlns:a16="http://schemas.microsoft.com/office/drawing/2014/main" id="{BA865AB0-FD87-874A-97CF-6FF09CB025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01DE97-4C2A-5541-BFCD-3963385E15CF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8" name="Espaço Reservado para Rodapé 7">
            <a:extLst>
              <a:ext uri="{FF2B5EF4-FFF2-40B4-BE49-F238E27FC236}">
                <a16:creationId xmlns:a16="http://schemas.microsoft.com/office/drawing/2014/main" id="{33DC2189-AFCF-A741-8DE2-8ED8386301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>
            <a:extLst>
              <a:ext uri="{FF2B5EF4-FFF2-40B4-BE49-F238E27FC236}">
                <a16:creationId xmlns:a16="http://schemas.microsoft.com/office/drawing/2014/main" id="{041B3488-850F-E542-B898-DBD8D5EBCB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EFF073-A968-994A-B6F4-4DB2CA7BF4AA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7724608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56E0CCF-C580-9142-9C32-9E1CE94E53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>
            <a:extLst>
              <a:ext uri="{FF2B5EF4-FFF2-40B4-BE49-F238E27FC236}">
                <a16:creationId xmlns:a16="http://schemas.microsoft.com/office/drawing/2014/main" id="{DCC5DE20-767C-AF4F-88F5-E02F2D00FA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01DE97-4C2A-5541-BFCD-3963385E15CF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4" name="Espaço Reservado para Rodapé 3">
            <a:extLst>
              <a:ext uri="{FF2B5EF4-FFF2-40B4-BE49-F238E27FC236}">
                <a16:creationId xmlns:a16="http://schemas.microsoft.com/office/drawing/2014/main" id="{11603049-BEE6-FC4C-81D8-A93B33587C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:a16="http://schemas.microsoft.com/office/drawing/2014/main" id="{7AB94804-B9A0-1A45-AD4F-37B5F0CF1D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EFF073-A968-994A-B6F4-4DB2CA7BF4AA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960144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>
            <a:extLst>
              <a:ext uri="{FF2B5EF4-FFF2-40B4-BE49-F238E27FC236}">
                <a16:creationId xmlns:a16="http://schemas.microsoft.com/office/drawing/2014/main" id="{9FA30439-210B-0442-B1AE-29631A8C78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01DE97-4C2A-5541-BFCD-3963385E15CF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3" name="Espaço Reservado para Rodapé 2">
            <a:extLst>
              <a:ext uri="{FF2B5EF4-FFF2-40B4-BE49-F238E27FC236}">
                <a16:creationId xmlns:a16="http://schemas.microsoft.com/office/drawing/2014/main" id="{A108B89A-7DB2-EB43-8F39-A0B277DB3C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F5CF2243-029A-E647-BCF5-2D4F871ED6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EFF073-A968-994A-B6F4-4DB2CA7BF4AA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4495593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8200128-653A-F546-A8E1-7EA7C72821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7A2AF8F1-775D-A44B-8B01-10F31363443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28F2ED73-8DD9-6445-BC74-DD54037C37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7CF0A285-E851-DB44-AA4C-30177C70B8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01DE97-4C2A-5541-BFCD-3963385E15CF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5D57708E-EF8F-814E-8FDA-7F28E427D3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ACFA7109-A6B5-BD4F-B542-87050F782D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EFF073-A968-994A-B6F4-4DB2CA7BF4AA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160344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D44221F-C127-9941-9669-E1FD6A6B1F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>
            <a:extLst>
              <a:ext uri="{FF2B5EF4-FFF2-40B4-BE49-F238E27FC236}">
                <a16:creationId xmlns:a16="http://schemas.microsoft.com/office/drawing/2014/main" id="{632D65D9-074D-8B43-808F-FDE046E94F0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7D5FC077-09DF-AB44-AE01-131EAB8DFB7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639EA4D1-10D5-0040-ADEA-FB4A59AB9A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01DE97-4C2A-5541-BFCD-3963385E15CF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BD2CB8DF-E08F-324A-B184-4DB3262651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ED91C7E6-877C-B74D-9334-6E22B7C15C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EFF073-A968-994A-B6F4-4DB2CA7BF4AA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6508563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>
            <a:extLst>
              <a:ext uri="{FF2B5EF4-FFF2-40B4-BE49-F238E27FC236}">
                <a16:creationId xmlns:a16="http://schemas.microsoft.com/office/drawing/2014/main" id="{43642141-F9A8-BB40-9758-6CB04611D9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F997A206-D2B3-8F42-B2B6-23DB71F42D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CB310CC4-3BF5-BE4D-895B-E25E6DAD4EB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01DE97-4C2A-5541-BFCD-3963385E15CF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7763790D-6446-C148-8151-C37ED4B0557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48E49E41-90A5-E943-8ABC-5A7A4087232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EFF073-A968-994A-B6F4-4DB2CA7BF4AA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6390796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ixaDeTexto 4">
            <a:extLst>
              <a:ext uri="{FF2B5EF4-FFF2-40B4-BE49-F238E27FC236}">
                <a16:creationId xmlns:a16="http://schemas.microsoft.com/office/drawing/2014/main" id="{A5D4AB16-99E0-BF40-986A-5694E76CC522}"/>
              </a:ext>
            </a:extLst>
          </p:cNvPr>
          <p:cNvSpPr txBox="1"/>
          <p:nvPr/>
        </p:nvSpPr>
        <p:spPr>
          <a:xfrm>
            <a:off x="476518" y="5032359"/>
            <a:ext cx="10985679" cy="4222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6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 5 : Second peak of systolic velocity (P2) - Mean difference between all pre-eclampsia group and control group.</a:t>
            </a:r>
            <a:endParaRPr lang="pt-BR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6" name="Agrupar 5">
            <a:extLst>
              <a:ext uri="{FF2B5EF4-FFF2-40B4-BE49-F238E27FC236}">
                <a16:creationId xmlns:a16="http://schemas.microsoft.com/office/drawing/2014/main" id="{D45DC3AA-9D5F-0C43-A5A4-DA89CD91DB59}"/>
              </a:ext>
            </a:extLst>
          </p:cNvPr>
          <p:cNvGrpSpPr/>
          <p:nvPr/>
        </p:nvGrpSpPr>
        <p:grpSpPr>
          <a:xfrm>
            <a:off x="476518" y="1712889"/>
            <a:ext cx="10818254" cy="3200519"/>
            <a:chOff x="0" y="1532466"/>
            <a:chExt cx="12192000" cy="3793067"/>
          </a:xfrm>
        </p:grpSpPr>
        <p:pic>
          <p:nvPicPr>
            <p:cNvPr id="7" name="Picture 3" descr="Chart, box and whisker chart&#10;&#10;Description automatically generated">
              <a:extLst>
                <a:ext uri="{FF2B5EF4-FFF2-40B4-BE49-F238E27FC236}">
                  <a16:creationId xmlns:a16="http://schemas.microsoft.com/office/drawing/2014/main" id="{83A837F9-974A-E648-AE2F-0E3688F904D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1532466"/>
              <a:ext cx="12192000" cy="3793067"/>
            </a:xfrm>
            <a:prstGeom prst="rect">
              <a:avLst/>
            </a:prstGeom>
          </p:spPr>
        </p:pic>
        <p:sp>
          <p:nvSpPr>
            <p:cNvPr id="8" name="CaixaDeTexto 7">
              <a:extLst>
                <a:ext uri="{FF2B5EF4-FFF2-40B4-BE49-F238E27FC236}">
                  <a16:creationId xmlns:a16="http://schemas.microsoft.com/office/drawing/2014/main" id="{DF6FF4CD-538C-F447-BFD9-F3BA4515CED6}"/>
                </a:ext>
              </a:extLst>
            </p:cNvPr>
            <p:cNvSpPr txBox="1"/>
            <p:nvPr/>
          </p:nvSpPr>
          <p:spPr>
            <a:xfrm>
              <a:off x="609603" y="3678018"/>
              <a:ext cx="735106" cy="36475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pt-BR" sz="1400" dirty="0">
                  <a:latin typeface="Arial" panose="020B0604020202020204" pitchFamily="34" charset="0"/>
                  <a:cs typeface="Arial" panose="020B0604020202020204" pitchFamily="34" charset="0"/>
                </a:rPr>
                <a:t>202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72574516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3</Words>
  <Application>Microsoft Macintosh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Microsoft Office User</dc:creator>
  <cp:lastModifiedBy>Microsoft Office User</cp:lastModifiedBy>
  <cp:revision>4</cp:revision>
  <dcterms:created xsi:type="dcterms:W3CDTF">2022-02-06T19:28:11Z</dcterms:created>
  <dcterms:modified xsi:type="dcterms:W3CDTF">2022-02-06T21:14:48Z</dcterms:modified>
</cp:coreProperties>
</file>